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9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8DCAEE-83BB-4D7A-B2C5-BE2708DF52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F1F222-50AA-4DBB-BA5D-DD944738EB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35839-C1A6-475A-889D-EE74A7A55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BD02F-AADB-48F6-8DD6-0DB66492C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D6894C-FEFF-4523-A906-5E500CFDA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645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5DEEB-D70F-4818-B981-0F52378BB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18FC8A-5DB1-430E-B6C8-2D7C890979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21C8BE-3AD9-4939-9EF6-8616EBC46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8160AC-C270-4AA6-ADFC-371D75F26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B3BCD-4017-43C8-A91E-62A252CAE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332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7E0B84-8EFC-435F-9CC4-FAEB5D01FD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28DFC2-88B8-4FBE-BA29-1A8F471A2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57D802-3213-43E8-B58C-05D560234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C1367D-C4C5-4692-904D-6DE8CCA31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D74F80-CE19-4E50-A373-AC574152E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9778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9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18826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70612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0"/>
            <a:ext cx="103632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7"/>
            <a:ext cx="103632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49803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4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4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17560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5" y="1535113"/>
            <a:ext cx="5386917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5" y="2174875"/>
            <a:ext cx="5386917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3" y="1535113"/>
            <a:ext cx="5389033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3" y="2174875"/>
            <a:ext cx="5389033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1241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6781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30335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6" y="273050"/>
            <a:ext cx="4011084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8" y="273054"/>
            <a:ext cx="6815668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6" y="1435104"/>
            <a:ext cx="4011084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005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DA34F-759B-44D3-AD75-B2CD3D14FC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5D5552-BEB4-40E9-BD5C-A96113E798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748347-E3A2-4BD8-B1F7-CB6359023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172CBD-6D76-42A1-8D19-E9B852C90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3926D-2FF4-4CE1-B199-31CEF006E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77627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1"/>
            <a:ext cx="73152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9"/>
            <a:ext cx="73152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52404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61346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63677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7382" y="1412778"/>
            <a:ext cx="11137237" cy="4896544"/>
          </a:xfrm>
        </p:spPr>
        <p:txBody>
          <a:bodyPr/>
          <a:lstStyle>
            <a:lvl1pPr>
              <a:buClr>
                <a:schemeClr val="bg2"/>
              </a:buClr>
              <a:defRPr/>
            </a:lvl1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1569833" y="6476216"/>
            <a:ext cx="384043" cy="365125"/>
          </a:xfrm>
        </p:spPr>
        <p:txBody>
          <a:bodyPr/>
          <a:lstStyle>
            <a:lvl1pPr algn="r">
              <a:defRPr/>
            </a:lvl1pPr>
          </a:lstStyle>
          <a:p>
            <a:fld id="{2FE18977-94FB-415F-B497-03350E8854FC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3"/>
          </p:nvPr>
        </p:nvSpPr>
        <p:spPr>
          <a:xfrm>
            <a:off x="523878" y="707465"/>
            <a:ext cx="9892606" cy="417287"/>
          </a:xfrm>
        </p:spPr>
        <p:txBody>
          <a:bodyPr/>
          <a:lstStyle>
            <a:lvl1pPr marL="0" indent="0">
              <a:buNone/>
              <a:defRPr sz="1350">
                <a:latin typeface="+mj-lt"/>
              </a:defRPr>
            </a:lvl1pPr>
            <a:lvl2pPr marL="269081" indent="0">
              <a:buNone/>
              <a:defRPr>
                <a:latin typeface="Cambria" pitchFamily="18" charset="0"/>
              </a:defRPr>
            </a:lvl2pPr>
            <a:lvl3pPr marL="538163" indent="0">
              <a:buNone/>
              <a:defRPr>
                <a:latin typeface="Cambria" pitchFamily="18" charset="0"/>
              </a:defRPr>
            </a:lvl3pPr>
            <a:lvl4pPr marL="807244" indent="0">
              <a:buNone/>
              <a:defRPr>
                <a:latin typeface="Cambria" pitchFamily="18" charset="0"/>
              </a:defRPr>
            </a:lvl4pPr>
            <a:lvl5pPr marL="1076325" indent="0">
              <a:buNone/>
              <a:defRPr>
                <a:latin typeface="Cambria" pitchFamily="18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Date Placeholder 3"/>
          <p:cNvSpPr>
            <a:spLocks noGrp="1"/>
          </p:cNvSpPr>
          <p:nvPr>
            <p:ph type="dt" sz="half" idx="10"/>
          </p:nvPr>
        </p:nvSpPr>
        <p:spPr>
          <a:xfrm>
            <a:off x="2351253" y="6476216"/>
            <a:ext cx="1433348" cy="365125"/>
          </a:xfrm>
        </p:spPr>
        <p:txBody>
          <a:bodyPr/>
          <a:lstStyle/>
          <a:p>
            <a:fld id="{1593C46D-29FD-4083-9AFE-3379C019586B}" type="datetime1">
              <a:rPr lang="en-US" smtClean="0"/>
              <a:pPr/>
              <a:t>1/28/2019</a:t>
            </a:fld>
            <a:endParaRPr lang="en-GB" dirty="0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27051" y="6476216"/>
            <a:ext cx="1824203" cy="365125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1496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FAF9F-DA4C-4345-A2D1-567F863288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CD3DEA-7F0D-419D-9E77-9314777A5B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27C1C6-4688-45CA-9971-36C450196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B0F75-D1F4-47C8-920A-E702465A7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8F283D-9328-465B-9D5B-16AB1E4E3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575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20016-1A13-4924-B009-FC5D169301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56B6F4-B951-4E0B-9483-4CD8A70234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B1F782-08B9-4506-864A-D7D488466C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5B36B9-B76C-4F71-938F-0AE0437760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BD414B-201B-496B-B260-046E04608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3EF494-6320-4176-8ED4-7C99838B9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393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D9597-A282-4565-8E16-FB7C02A596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B75891-939D-4E51-99D6-9DDEF8DC2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60D406-829E-45AD-8D66-9D54278957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01A37C-E87F-4696-97E2-7153D120D4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C0A2B-38CA-4B1C-B373-D11027DE92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11FCEF-B18B-4D99-9DA1-87C79CCA2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591915-0E3D-4989-AC98-EDE404509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3417DE-5B18-46C1-9728-55CABF8E2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363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5AF85-464B-4AC6-AF23-6D1B726C2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EA08AF-DA4B-44BC-903D-0C17EC499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0B75F9C-85BB-4683-8EA5-9260279BF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A2E758-8492-4DB0-A1AD-6995F8486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032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52F436-FF4D-4C19-A6C4-D02AEA187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96737D-954F-4962-AF48-855A46338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3B6462-AFCC-4FBD-AC9D-9C219DFE5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042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1A8F26-F0BE-4265-A822-23D3D86703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BE0B7B-2A0B-4D33-B9DB-A10AD1871F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54E69B-3BC2-4CF3-896D-ADCEBFC8D3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A8D0B-6A65-43B0-84D5-C4189094C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791C93-E7C3-49F9-8C69-AA839C7F7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985280-59AB-4B05-BDD7-42AA48423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610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DA25CE-6E8F-4BC1-A967-653AA5C21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83C85C-BD48-4027-B79C-AEBEEAFF3D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D8461F-0C39-4168-B9C5-0A73752DC0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DBF8E4-AFB0-4756-95A9-21282F69F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AEDB96-0337-4C8E-8454-D54D7BB5E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29D907-EE2F-4DCA-97B9-A3C10FB98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69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DF534F-04DE-4F56-8636-4D9FEF2AF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F0CDD0-F524-4BAC-85B7-0985E04C24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63A3C0-FFBB-4B28-BCA7-8656664389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F7429-9460-4021-AD7C-145A5EADEB53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B15644-4C4F-4101-9598-43C44379ED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9815B5-30F6-4922-B544-7EB86BBCA6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0EF37-32DE-4D8C-B2D1-117B5E311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18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4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4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2EFCF-879D-49CA-B872-764F7C2D3592}" type="datetimeFigureOut">
              <a:rPr lang="en-US" smtClean="0"/>
              <a:pPr/>
              <a:t>1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4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4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FD035-45A4-473E-B78B-F63651F9AE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311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0439991"/>
              </p:ext>
            </p:extLst>
          </p:nvPr>
        </p:nvGraphicFramePr>
        <p:xfrm>
          <a:off x="1589104" y="577050"/>
          <a:ext cx="8407152" cy="5576610"/>
        </p:xfrm>
        <a:graphic>
          <a:graphicData uri="http://schemas.openxmlformats.org/drawingml/2006/table">
            <a:tbl>
              <a:tblPr firstRow="1" firstCol="1" bandRow="1">
                <a:tableStyleId>{46F890A9-2807-4EBB-B81D-B2AA78EC7F39}</a:tableStyleId>
              </a:tblPr>
              <a:tblGrid>
                <a:gridCol w="36664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6665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668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718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639191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Selected trait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# SNP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#Intergenic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#</a:t>
                      </a:r>
                      <a:r>
                        <a:rPr lang="en-US" sz="1800" u="none" strike="noStrike" dirty="0" err="1">
                          <a:latin typeface="+mj-lt"/>
                        </a:rPr>
                        <a:t>Intragenic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552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Adiposity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chemeClr val="dk1"/>
                          </a:solidFill>
                          <a:latin typeface="+mj-lt"/>
                          <a:cs typeface="+mn-cs"/>
                        </a:rPr>
                        <a:t>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68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Body</a:t>
                      </a:r>
                      <a:r>
                        <a:rPr lang="en-US" sz="1800" b="1" i="0" u="none" strike="noStrike" baseline="0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 fat percentage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12</a:t>
                      </a: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6</a:t>
                      </a: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6</a:t>
                      </a: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15453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Body mass (lean)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5191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Body mass inde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13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6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4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1841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Fat body mas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552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Obesity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5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768036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Visceral adipose tissue/</a:t>
                      </a:r>
                    </a:p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subcutaneous adipose tissue ratio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4085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Waist circumference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6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68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Waist-hip ratio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8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2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57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552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Weight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5</a:t>
                      </a: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6</a:t>
                      </a: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53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latin typeface="+mj-lt"/>
                          <a:cs typeface="Arial" pitchFamily="34" charset="0"/>
                        </a:rPr>
                        <a:t>Weight loss (gastric bypass surgery)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latin typeface="+mj-lt"/>
                        </a:rPr>
                        <a:t>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5520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TOTAL</a:t>
                      </a: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324</a:t>
                      </a: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163</a:t>
                      </a:r>
                    </a:p>
                  </a:txBody>
                  <a:tcPr marL="34290" marR="2429" marT="242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1" u="none" strike="noStrike" dirty="0">
                          <a:solidFill>
                            <a:srgbClr val="000000"/>
                          </a:solidFill>
                          <a:latin typeface="+mj-lt"/>
                          <a:cs typeface="Arial" pitchFamily="34" charset="0"/>
                        </a:rPr>
                        <a:t>161</a:t>
                      </a:r>
                    </a:p>
                  </a:txBody>
                  <a:tcPr marL="34290" marR="2429" marT="2429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1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Office Theme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arm User</dc:creator>
  <cp:lastModifiedBy>Pharm User</cp:lastModifiedBy>
  <cp:revision>1</cp:revision>
  <dcterms:created xsi:type="dcterms:W3CDTF">2019-01-28T18:21:25Z</dcterms:created>
  <dcterms:modified xsi:type="dcterms:W3CDTF">2019-01-28T18:23:57Z</dcterms:modified>
</cp:coreProperties>
</file>